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145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294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990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31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058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538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62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4868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371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066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942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757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Kliknutím lze upravit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FF56B-5EAD-403B-99FD-98256CF2F6DE}" type="datetimeFigureOut">
              <a:rPr lang="en-US" smtClean="0"/>
              <a:t>9/24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7DBDF-0DE6-4B94-B37A-0D65F1D19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371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Skupina 1"/>
          <p:cNvGrpSpPr/>
          <p:nvPr/>
        </p:nvGrpSpPr>
        <p:grpSpPr>
          <a:xfrm>
            <a:off x="179512" y="11966"/>
            <a:ext cx="8833792" cy="6812296"/>
            <a:chOff x="179512" y="11966"/>
            <a:chExt cx="8833792" cy="6812296"/>
          </a:xfrm>
        </p:grpSpPr>
        <p:grpSp>
          <p:nvGrpSpPr>
            <p:cNvPr id="8" name="Skupina 7"/>
            <p:cNvGrpSpPr/>
            <p:nvPr/>
          </p:nvGrpSpPr>
          <p:grpSpPr>
            <a:xfrm>
              <a:off x="179512" y="33738"/>
              <a:ext cx="5760640" cy="3713925"/>
              <a:chOff x="179512" y="33738"/>
              <a:chExt cx="5760640" cy="3713925"/>
            </a:xfrm>
          </p:grpSpPr>
          <p:sp>
            <p:nvSpPr>
              <p:cNvPr id="13" name="TextovéPole 12"/>
              <p:cNvSpPr txBox="1"/>
              <p:nvPr/>
            </p:nvSpPr>
            <p:spPr>
              <a:xfrm>
                <a:off x="179512" y="3439886"/>
                <a:ext cx="5760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1400" b="1" dirty="0"/>
                  <a:t>GPX3				                    GPX4</a:t>
                </a:r>
                <a:endParaRPr lang="en-US" sz="1400" b="1" dirty="0"/>
              </a:p>
            </p:txBody>
          </p:sp>
          <p:sp>
            <p:nvSpPr>
              <p:cNvPr id="15" name="TextovéPole 14"/>
              <p:cNvSpPr txBox="1"/>
              <p:nvPr/>
            </p:nvSpPr>
            <p:spPr>
              <a:xfrm>
                <a:off x="179512" y="33738"/>
                <a:ext cx="5760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1400" b="1" dirty="0"/>
                  <a:t>GPX1				                    GPX2</a:t>
                </a:r>
                <a:endParaRPr lang="en-US" sz="1400" b="1" dirty="0"/>
              </a:p>
            </p:txBody>
          </p:sp>
        </p:grp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6" y="11966"/>
              <a:ext cx="3831332" cy="33025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8064" y="12582"/>
              <a:ext cx="3865240" cy="33019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5577" y="3487298"/>
              <a:ext cx="3831332" cy="3336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8064" y="3474166"/>
              <a:ext cx="3865239" cy="33500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7574062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Skupina 5"/>
          <p:cNvGrpSpPr/>
          <p:nvPr/>
        </p:nvGrpSpPr>
        <p:grpSpPr>
          <a:xfrm>
            <a:off x="0" y="11966"/>
            <a:ext cx="9085764" cy="6849877"/>
            <a:chOff x="0" y="11966"/>
            <a:chExt cx="9085764" cy="6849877"/>
          </a:xfrm>
        </p:grpSpPr>
        <p:grpSp>
          <p:nvGrpSpPr>
            <p:cNvPr id="2" name="Skupina 1"/>
            <p:cNvGrpSpPr/>
            <p:nvPr/>
          </p:nvGrpSpPr>
          <p:grpSpPr>
            <a:xfrm>
              <a:off x="0" y="55657"/>
              <a:ext cx="6444208" cy="3692153"/>
              <a:chOff x="328345" y="54756"/>
              <a:chExt cx="5785141" cy="3390542"/>
            </a:xfrm>
          </p:grpSpPr>
          <p:sp>
            <p:nvSpPr>
              <p:cNvPr id="15" name="TextovéPole 14"/>
              <p:cNvSpPr txBox="1"/>
              <p:nvPr/>
            </p:nvSpPr>
            <p:spPr>
              <a:xfrm>
                <a:off x="328346" y="54756"/>
                <a:ext cx="5720497" cy="2826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1400" b="1" dirty="0"/>
                  <a:t>SELENOF				                     SELENOH</a:t>
                </a:r>
                <a:endParaRPr lang="en-US" sz="1400" b="1" dirty="0"/>
              </a:p>
            </p:txBody>
          </p:sp>
          <p:sp>
            <p:nvSpPr>
              <p:cNvPr id="13" name="TextovéPole 12"/>
              <p:cNvSpPr txBox="1"/>
              <p:nvPr/>
            </p:nvSpPr>
            <p:spPr>
              <a:xfrm>
                <a:off x="328345" y="3162663"/>
                <a:ext cx="5785141" cy="2826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1400" b="1" dirty="0"/>
                  <a:t>SELENOK				                     SELENON</a:t>
                </a:r>
                <a:endParaRPr lang="en-US" sz="1400" b="1" dirty="0"/>
              </a:p>
            </p:txBody>
          </p:sp>
        </p:grpSp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4927" y="55657"/>
              <a:ext cx="3705066" cy="3157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64088" y="11966"/>
              <a:ext cx="3711758" cy="32010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4926" y="3494039"/>
              <a:ext cx="3705066" cy="33678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64088" y="3494039"/>
              <a:ext cx="3721676" cy="3347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41440584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Skupina 6"/>
          <p:cNvGrpSpPr/>
          <p:nvPr/>
        </p:nvGrpSpPr>
        <p:grpSpPr>
          <a:xfrm>
            <a:off x="107504" y="17647"/>
            <a:ext cx="9001001" cy="6796081"/>
            <a:chOff x="107504" y="17647"/>
            <a:chExt cx="9001001" cy="6796081"/>
          </a:xfrm>
        </p:grpSpPr>
        <p:grpSp>
          <p:nvGrpSpPr>
            <p:cNvPr id="2" name="Skupina 1"/>
            <p:cNvGrpSpPr/>
            <p:nvPr/>
          </p:nvGrpSpPr>
          <p:grpSpPr>
            <a:xfrm>
              <a:off x="107504" y="44624"/>
              <a:ext cx="6408712" cy="3722644"/>
              <a:chOff x="395536" y="44624"/>
              <a:chExt cx="5544616" cy="3190643"/>
            </a:xfrm>
          </p:grpSpPr>
          <p:sp>
            <p:nvSpPr>
              <p:cNvPr id="13" name="TextovéPole 12"/>
              <p:cNvSpPr txBox="1"/>
              <p:nvPr/>
            </p:nvSpPr>
            <p:spPr>
              <a:xfrm>
                <a:off x="395536" y="2971474"/>
                <a:ext cx="5544616" cy="2637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1400" b="1" dirty="0"/>
                  <a:t>SELENOW				                        SEPHS2</a:t>
                </a:r>
                <a:endParaRPr lang="en-US" sz="1400" b="1" dirty="0"/>
              </a:p>
            </p:txBody>
          </p:sp>
          <p:sp>
            <p:nvSpPr>
              <p:cNvPr id="15" name="TextovéPole 14"/>
              <p:cNvSpPr txBox="1"/>
              <p:nvPr/>
            </p:nvSpPr>
            <p:spPr>
              <a:xfrm>
                <a:off x="395536" y="44624"/>
                <a:ext cx="5328592" cy="2637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1400" b="1" dirty="0"/>
                  <a:t>SELENOP				                      SELENOS</a:t>
                </a:r>
                <a:endParaRPr lang="en-US" sz="1400" b="1" dirty="0"/>
              </a:p>
            </p:txBody>
          </p:sp>
        </p:grpSp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1600" y="17648"/>
              <a:ext cx="3596478" cy="3329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72666" y="17647"/>
              <a:ext cx="3635838" cy="33393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1600" y="3538285"/>
              <a:ext cx="3562773" cy="3275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78" name="Picture 6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72667" y="3502220"/>
              <a:ext cx="3635838" cy="33111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7578517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Skupina 6"/>
          <p:cNvGrpSpPr/>
          <p:nvPr/>
        </p:nvGrpSpPr>
        <p:grpSpPr>
          <a:xfrm>
            <a:off x="107504" y="25216"/>
            <a:ext cx="8939878" cy="6809932"/>
            <a:chOff x="107504" y="25216"/>
            <a:chExt cx="8939878" cy="6809932"/>
          </a:xfrm>
        </p:grpSpPr>
        <p:grpSp>
          <p:nvGrpSpPr>
            <p:cNvPr id="2" name="Skupina 1"/>
            <p:cNvGrpSpPr/>
            <p:nvPr/>
          </p:nvGrpSpPr>
          <p:grpSpPr>
            <a:xfrm>
              <a:off x="107504" y="44624"/>
              <a:ext cx="5544616" cy="3692153"/>
              <a:chOff x="179512" y="44624"/>
              <a:chExt cx="5544616" cy="3692153"/>
            </a:xfrm>
          </p:grpSpPr>
          <p:sp>
            <p:nvSpPr>
              <p:cNvPr id="13" name="TextovéPole 12"/>
              <p:cNvSpPr txBox="1"/>
              <p:nvPr/>
            </p:nvSpPr>
            <p:spPr>
              <a:xfrm>
                <a:off x="179512" y="3429000"/>
                <a:ext cx="554461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1400" b="1" dirty="0"/>
                  <a:t>TXNRD3				                     SELENBP1</a:t>
                </a:r>
                <a:endParaRPr lang="en-US" sz="1400" b="1" dirty="0"/>
              </a:p>
            </p:txBody>
          </p:sp>
          <p:sp>
            <p:nvSpPr>
              <p:cNvPr id="15" name="TextovéPole 14"/>
              <p:cNvSpPr txBox="1"/>
              <p:nvPr/>
            </p:nvSpPr>
            <p:spPr>
              <a:xfrm>
                <a:off x="251520" y="44624"/>
                <a:ext cx="532859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1400" b="1" dirty="0"/>
                  <a:t>TXNRD1				                     TXNRD2</a:t>
                </a:r>
                <a:endParaRPr lang="en-US" sz="1400" b="1" dirty="0"/>
              </a:p>
            </p:txBody>
          </p:sp>
        </p:grpSp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0053" y="25216"/>
              <a:ext cx="3595983" cy="32299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52447" y="44623"/>
              <a:ext cx="3591064" cy="31900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9091" y="3501009"/>
              <a:ext cx="3605822" cy="33325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41561" y="3523090"/>
              <a:ext cx="3605821" cy="33120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4992898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332656"/>
            <a:ext cx="3851920" cy="33796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ovéPole 14"/>
          <p:cNvSpPr txBox="1"/>
          <p:nvPr/>
        </p:nvSpPr>
        <p:spPr>
          <a:xfrm>
            <a:off x="179512" y="96887"/>
            <a:ext cx="648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b="1" dirty="0"/>
              <a:t>SOD2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552145317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9</Words>
  <Application>Microsoft Office PowerPoint</Application>
  <PresentationFormat>On-screen Show (4:3)</PresentationFormat>
  <Paragraphs>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Motiv systému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tátní zdravotní ústav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Pavel Souček</dc:creator>
  <cp:lastModifiedBy>UCD</cp:lastModifiedBy>
  <cp:revision>20</cp:revision>
  <dcterms:created xsi:type="dcterms:W3CDTF">2018-05-29T16:42:18Z</dcterms:created>
  <dcterms:modified xsi:type="dcterms:W3CDTF">2018-09-24T18:10:33Z</dcterms:modified>
</cp:coreProperties>
</file>